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2040" y="-2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wxhu\gsea_home\output\apr29\my_analysis.Gsea.1556514122978\enplot_HALLMARK_EPITHELIAL_MESENCHYMAL_TRANSITION_6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71472" y="285728"/>
            <a:ext cx="1785950" cy="1785950"/>
          </a:xfrm>
          <a:prstGeom prst="rect">
            <a:avLst/>
          </a:prstGeom>
          <a:noFill/>
        </p:spPr>
      </p:pic>
      <p:pic>
        <p:nvPicPr>
          <p:cNvPr id="1027" name="Picture 3" descr="C:\Users\wxhu\gsea_home\output\apr29\my_analysis.Gsea.1556514122978\enplot_HALLMARK_APICAL_JUNCTION_9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714612" y="285728"/>
            <a:ext cx="1785950" cy="1785950"/>
          </a:xfrm>
          <a:prstGeom prst="rect">
            <a:avLst/>
          </a:prstGeom>
          <a:noFill/>
        </p:spPr>
      </p:pic>
      <p:pic>
        <p:nvPicPr>
          <p:cNvPr id="1028" name="Picture 4" descr="C:\Users\wxhu\gsea_home\output\apr29\my_analysis.Gsea.1556514122978\enplot_HALLMARK_KRAS_SIGNALING_UP_12.pn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57752" y="285728"/>
            <a:ext cx="1785950" cy="1785950"/>
          </a:xfrm>
          <a:prstGeom prst="rect">
            <a:avLst/>
          </a:prstGeom>
          <a:noFill/>
        </p:spPr>
      </p:pic>
      <p:pic>
        <p:nvPicPr>
          <p:cNvPr id="1029" name="Picture 5" descr="C:\Users\wxhu\gsea_home\output\apr29\my_analysis.Gsea.1556514122978\enplot_HALLMARK_MYOGENESIS_30.png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977064" y="285728"/>
            <a:ext cx="1785950" cy="1785950"/>
          </a:xfrm>
          <a:prstGeom prst="rect">
            <a:avLst/>
          </a:prstGeom>
          <a:noFill/>
        </p:spPr>
      </p:pic>
      <p:pic>
        <p:nvPicPr>
          <p:cNvPr id="1030" name="Picture 6" descr="C:\Users\wxhu\gsea_home\output\apr29\my_analysis.Gsea.1556514122978\enplot_HALLMARK_E2F_TARGETS_69.png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71472" y="2357430"/>
            <a:ext cx="1785950" cy="1785950"/>
          </a:xfrm>
          <a:prstGeom prst="rect">
            <a:avLst/>
          </a:prstGeom>
          <a:noFill/>
        </p:spPr>
      </p:pic>
      <p:pic>
        <p:nvPicPr>
          <p:cNvPr id="1031" name="Picture 7" descr="C:\Users\wxhu\gsea_home\output\apr29\my_analysis.Gsea.1556514122978\enplot_HALLMARK_MYC_TARGETS_V1_66.png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714612" y="2357430"/>
            <a:ext cx="1785950" cy="1785950"/>
          </a:xfrm>
          <a:prstGeom prst="rect">
            <a:avLst/>
          </a:prstGeom>
          <a:noFill/>
        </p:spPr>
      </p:pic>
      <p:pic>
        <p:nvPicPr>
          <p:cNvPr id="1032" name="Picture 8" descr="C:\Users\wxhu\gsea_home\output\apr29\my_analysis.Gsea.1556514122978\enplot_HALLMARK_MTORC1_SIGNALING_81.png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4857752" y="2357430"/>
            <a:ext cx="1785950" cy="1785950"/>
          </a:xfrm>
          <a:prstGeom prst="rect">
            <a:avLst/>
          </a:prstGeom>
          <a:noFill/>
        </p:spPr>
      </p:pic>
      <p:pic>
        <p:nvPicPr>
          <p:cNvPr id="1033" name="Picture 9" descr="C:\Users\wxhu\gsea_home\output\apr29\my_analysis.Gsea.1556514122978\enplot_HALLMARK_GLYCOLYSIS_87.png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7000892" y="2357430"/>
            <a:ext cx="1785950" cy="1785950"/>
          </a:xfrm>
          <a:prstGeom prst="rect">
            <a:avLst/>
          </a:prstGeom>
          <a:noFill/>
        </p:spPr>
      </p:pic>
      <p:pic>
        <p:nvPicPr>
          <p:cNvPr id="1034" name="Picture 10" descr="C:\Users\wxhu\gsea_home\output\apr29\my_analysis.Gsea.1556514122978\enplot_HALLMARK_G2M_CHECKPOINT_84.png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571472" y="4500570"/>
            <a:ext cx="1785950" cy="1785950"/>
          </a:xfrm>
          <a:prstGeom prst="rect">
            <a:avLst/>
          </a:prstGeom>
          <a:noFill/>
        </p:spPr>
      </p:pic>
      <p:pic>
        <p:nvPicPr>
          <p:cNvPr id="1035" name="Picture 11" descr="C:\Users\wxhu\gsea_home\output\apr29\my_analysis.Gsea.1556514122978\enplot_HALLMARK_OXIDATIVE_PHOSPHORYLATION_63.png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2714612" y="4500570"/>
            <a:ext cx="1785950" cy="1785950"/>
          </a:xfrm>
          <a:prstGeom prst="rect">
            <a:avLst/>
          </a:prstGeom>
          <a:noFill/>
        </p:spPr>
      </p:pic>
      <p:sp>
        <p:nvSpPr>
          <p:cNvPr id="14" name="TextBox 13"/>
          <p:cNvSpPr txBox="1"/>
          <p:nvPr/>
        </p:nvSpPr>
        <p:spPr>
          <a:xfrm>
            <a:off x="285720" y="0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500298" y="0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714876" y="0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85720" y="2071678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e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786578" y="0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500298" y="2071678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643438" y="2071678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g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57158" y="4202676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i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786578" y="2071678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h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571736" y="4214818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j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4572000" y="5643578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altLang="zh-CN" sz="1200" smtClean="0">
                <a:latin typeface="Times New Roman" pitchFamily="18" charset="0"/>
                <a:cs typeface="Times New Roman" pitchFamily="18" charset="0"/>
              </a:rPr>
              <a:t>Figure S5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GSEA analysis revealed functional enrichment differences between MSI-H1 and MSI-H2. GSEA was performed for MSI-H CRCs using the hallmark gene signatures collected from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MSigDB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9</Words>
  <PresentationFormat>全屏显示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xhu</dc:creator>
  <cp:lastModifiedBy>wxhu</cp:lastModifiedBy>
  <cp:revision>5</cp:revision>
  <dcterms:created xsi:type="dcterms:W3CDTF">2019-05-14T01:00:36Z</dcterms:created>
  <dcterms:modified xsi:type="dcterms:W3CDTF">2019-05-15T06:41:33Z</dcterms:modified>
</cp:coreProperties>
</file>